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6858000" cy="9906000" type="A4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9" d="100"/>
          <a:sy n="69" d="100"/>
        </p:scale>
        <p:origin x="-1740" y="-1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F9908F9-8544-47C5-9F3F-483AC735BBC4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C85A78-23BE-4FB9-86EC-508154644AA7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9965931-EF72-46A5-A4BF-7C4E0FA55717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A3DE56D-3C18-45BF-99C8-1C042B7540B4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79121CF-E5CC-417C-9321-DEBF184A3B72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9D182F-796B-4EAE-8D3B-2B1996C721D9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5EEF258-BE5F-4F3C-9C14-C888D3191118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863716D-05C9-44FA-9DC3-E867B781ED84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A863B10-C957-4650-AC10-1A11935DE6A7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FDCCDD-3374-4554-8B37-E234C393BD72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D41181D-6FE7-4B70-AFE8-8CC4197450C8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1135424-5DF4-4A73-85AC-995401496103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930F7B4-793A-41F9-92F3-551DB36F07F1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C8B663E-512F-40D2-BDDD-59EFCEB15B4A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703EA1B-5429-4FD6-9C68-F040A9B29045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D8F890-6936-4548-BC06-A3370D1ABC7A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69F4191-EA00-48FB-9EFD-5946059EB1DC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7006988-2015-4B5F-AA0D-EBA1BDC66EEF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692AFA-E3C0-42FD-BD88-F8ADD723C1EB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61235F9-21D1-4350-981E-9A35034BF3CA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14D4D07-15A4-454D-941B-14565FAD93AA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D5EF7F3-C1BB-4DE2-9D44-AD7317E6CC90}" type="slidenum">
              <a:rPr lang="de-DE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0518F963-EBAE-4FCE-A074-75665FB23DE7}" type="datetime1">
              <a:rPr lang="de-DE"/>
              <a:pPr/>
              <a:t>28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51579BD7-0BE7-440E-9235-D519D9B7E7A3}" type="slidenum">
              <a:rPr lang="de-DE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-128"/>
          <a:cs typeface="ＭＳ Ｐゴシック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extfeld 5"/>
          <p:cNvSpPr txBox="1">
            <a:spLocks noChangeArrowheads="1"/>
          </p:cNvSpPr>
          <p:nvPr/>
        </p:nvSpPr>
        <p:spPr bwMode="auto">
          <a:xfrm>
            <a:off x="0" y="0"/>
            <a:ext cx="5715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 b="1" smtClean="0">
                <a:latin typeface="Calibri" charset="0"/>
              </a:rPr>
              <a:t>Additional file 2:  Figure S1</a:t>
            </a:r>
            <a:r>
              <a:rPr lang="de-DE" sz="1200" b="1" dirty="0">
                <a:latin typeface="Calibri" charset="0"/>
              </a:rPr>
              <a:t>.</a:t>
            </a:r>
          </a:p>
        </p:txBody>
      </p:sp>
      <p:pic>
        <p:nvPicPr>
          <p:cNvPr id="13315" name="Grafik 6" descr="heatmap_metabolites_small2_K_T.jp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2875" y="877888"/>
            <a:ext cx="6491288" cy="628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16" name="Textfeld 7"/>
          <p:cNvSpPr txBox="1">
            <a:spLocks noChangeArrowheads="1"/>
          </p:cNvSpPr>
          <p:nvPr/>
        </p:nvSpPr>
        <p:spPr bwMode="auto">
          <a:xfrm>
            <a:off x="2143125" y="1238250"/>
            <a:ext cx="150018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KORA</a:t>
            </a:r>
          </a:p>
        </p:txBody>
      </p:sp>
      <p:sp>
        <p:nvSpPr>
          <p:cNvPr id="13317" name="Textfeld 8"/>
          <p:cNvSpPr txBox="1">
            <a:spLocks noChangeArrowheads="1"/>
          </p:cNvSpPr>
          <p:nvPr/>
        </p:nvSpPr>
        <p:spPr bwMode="auto">
          <a:xfrm>
            <a:off x="4429125" y="1166813"/>
            <a:ext cx="128587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TwinsUK</a:t>
            </a:r>
          </a:p>
        </p:txBody>
      </p:sp>
      <p:sp>
        <p:nvSpPr>
          <p:cNvPr id="13318" name="Textfeld 9"/>
          <p:cNvSpPr txBox="1">
            <a:spLocks noChangeArrowheads="1"/>
          </p:cNvSpPr>
          <p:nvPr/>
        </p:nvSpPr>
        <p:spPr bwMode="auto">
          <a:xfrm>
            <a:off x="1428750" y="1738313"/>
            <a:ext cx="571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HDL</a:t>
            </a:r>
          </a:p>
        </p:txBody>
      </p:sp>
      <p:sp>
        <p:nvSpPr>
          <p:cNvPr id="13319" name="Textfeld 10"/>
          <p:cNvSpPr txBox="1">
            <a:spLocks noChangeArrowheads="1"/>
          </p:cNvSpPr>
          <p:nvPr/>
        </p:nvSpPr>
        <p:spPr bwMode="auto">
          <a:xfrm>
            <a:off x="2071688" y="1738313"/>
            <a:ext cx="571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TG</a:t>
            </a:r>
          </a:p>
        </p:txBody>
      </p:sp>
      <p:sp>
        <p:nvSpPr>
          <p:cNvPr id="13320" name="Textfeld 11"/>
          <p:cNvSpPr txBox="1">
            <a:spLocks noChangeArrowheads="1"/>
          </p:cNvSpPr>
          <p:nvPr/>
        </p:nvSpPr>
        <p:spPr bwMode="auto">
          <a:xfrm>
            <a:off x="2643188" y="1738313"/>
            <a:ext cx="571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LDL</a:t>
            </a:r>
          </a:p>
        </p:txBody>
      </p:sp>
      <p:sp>
        <p:nvSpPr>
          <p:cNvPr id="13321" name="Textfeld 12"/>
          <p:cNvSpPr txBox="1">
            <a:spLocks noChangeArrowheads="1"/>
          </p:cNvSpPr>
          <p:nvPr/>
        </p:nvSpPr>
        <p:spPr bwMode="auto">
          <a:xfrm>
            <a:off x="3286125" y="1738313"/>
            <a:ext cx="571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TC</a:t>
            </a:r>
          </a:p>
        </p:txBody>
      </p:sp>
      <p:sp>
        <p:nvSpPr>
          <p:cNvPr id="13322" name="Textfeld 13"/>
          <p:cNvSpPr txBox="1">
            <a:spLocks noChangeArrowheads="1"/>
          </p:cNvSpPr>
          <p:nvPr/>
        </p:nvSpPr>
        <p:spPr bwMode="auto">
          <a:xfrm>
            <a:off x="3929063" y="1738313"/>
            <a:ext cx="571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HDL</a:t>
            </a:r>
          </a:p>
        </p:txBody>
      </p:sp>
      <p:sp>
        <p:nvSpPr>
          <p:cNvPr id="13323" name="Textfeld 14"/>
          <p:cNvSpPr txBox="1">
            <a:spLocks noChangeArrowheads="1"/>
          </p:cNvSpPr>
          <p:nvPr/>
        </p:nvSpPr>
        <p:spPr bwMode="auto">
          <a:xfrm>
            <a:off x="4572000" y="1738313"/>
            <a:ext cx="571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TG</a:t>
            </a:r>
          </a:p>
        </p:txBody>
      </p:sp>
      <p:sp>
        <p:nvSpPr>
          <p:cNvPr id="13324" name="Textfeld 15"/>
          <p:cNvSpPr txBox="1">
            <a:spLocks noChangeArrowheads="1"/>
          </p:cNvSpPr>
          <p:nvPr/>
        </p:nvSpPr>
        <p:spPr bwMode="auto">
          <a:xfrm>
            <a:off x="5143500" y="1738313"/>
            <a:ext cx="571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LDL</a:t>
            </a:r>
          </a:p>
        </p:txBody>
      </p:sp>
      <p:sp>
        <p:nvSpPr>
          <p:cNvPr id="13325" name="Textfeld 16"/>
          <p:cNvSpPr txBox="1">
            <a:spLocks noChangeArrowheads="1"/>
          </p:cNvSpPr>
          <p:nvPr/>
        </p:nvSpPr>
        <p:spPr bwMode="auto">
          <a:xfrm>
            <a:off x="5786438" y="1738313"/>
            <a:ext cx="571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800">
                <a:latin typeface="Calibri" charset="0"/>
              </a:rPr>
              <a:t>TC</a:t>
            </a:r>
          </a:p>
        </p:txBody>
      </p:sp>
      <p:sp>
        <p:nvSpPr>
          <p:cNvPr id="20" name="Rechteck 19"/>
          <p:cNvSpPr/>
          <p:nvPr/>
        </p:nvSpPr>
        <p:spPr>
          <a:xfrm>
            <a:off x="1571625" y="6810375"/>
            <a:ext cx="4643438" cy="1428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 sz="1800">
              <a:solidFill>
                <a:srgbClr val="FFFFFF"/>
              </a:solidFill>
              <a:ea typeface="ＭＳ Ｐゴシック" charset="-128"/>
            </a:endParaRPr>
          </a:p>
        </p:txBody>
      </p:sp>
      <p:graphicFrame>
        <p:nvGraphicFramePr>
          <p:cNvPr id="18" name="Tabelle 17"/>
          <p:cNvGraphicFramePr>
            <a:graphicFrameLocks noGrp="1"/>
          </p:cNvGraphicFramePr>
          <p:nvPr/>
        </p:nvGraphicFramePr>
        <p:xfrm>
          <a:off x="285750" y="6926263"/>
          <a:ext cx="6500813" cy="2742883"/>
        </p:xfrm>
        <a:graphic>
          <a:graphicData uri="http://schemas.openxmlformats.org/drawingml/2006/table">
            <a:tbl>
              <a:tblPr/>
              <a:tblGrid>
                <a:gridCol w="1117600"/>
                <a:gridCol w="5383213"/>
              </a:tblGrid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Group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metabolites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PC.ae.C38.5, SM.C20.2, PC.ae.C38.1, PC.aa.C40.2, PC.ae.C40.5, PC.ae.C40.4, PC.ae.C40.3, PC.aa.C42.4, PC.ae.C38.2, PC.aa.C40.3, PC.aa.C36.5, PC.aa.C42.6, PC.ae.C40.0, PC.aa.C38.6, PC.aa.C36.6, PC.ae.C30.0, PC.ae.C34.0, PC.ae.C36.2, PC.ae.C34.1, PC.ae.C38.0, PC.ae.C36.0, PC.ae.C40.1, PC.ae.C42.2, PC.ae.C38.4, PC.ae.C36.4, PC.aa.C36.0, PC.ae.C40.6, SM..OH..C24.1, SM.C16.1, SM..OH..C16.1, SM..OH..C14.1, SM.C16.0, SM.C24.1, SM..OH..C22.2, SM.C26.1, SM.C26.0, PC.ae.C42.3, PC.aa.C42.2, PC.aa.C38.0, PC.ae.C32.2, PC.ae.C34.2, PC.ae.C32.1, PC.ae.C36.3, PC.ae.C38.6, PC.ae.C36.5, C14.1, PC.ae.C30.2, PC.aa.C42.5, PC.ae.C42.1, PC.ae.C44.3, PC.aa.C40.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PC.ae.C40.2, SM.C18.1, SM.C18.0, PC.ae.C38.3, PC.ae.C36.1, PC.aa.C32.3, PC.aa.C28.1, SM..OH..C22.1, SM.C24.0, PC.aa.C30.0, PC.aa.C32.0, PC.aa.C34.2, PC.aa.C36.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3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PC.ae.C34.3, lysoPC.a.C18.2, PC.aa.C42.0, PC.ae.C44.6, PC.ae.C44.5, PC.aa.C42.1, PC.ae.C42.4, PC.ae.C42.5, PC.ae.C44.4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4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PC.aa.C38.3, PC.aa.C40.4, PC.aa.C40.5, PC.aa.C32.1, PC.aa.C40.6, PC.aa.C38.4, PC.aa.C36.1, PC.aa.C36.3, PC.aa.C36.4, PC.aa.C38.5, PC.aa.C32.2, PC.aa.C34.3, PC.aa.C34.4, PC.aa.C34.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5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Ser, Gly, C12.DC,l ysoPC.a.C16.1, lysoPC.a.C14.0, lysoPC.a.C16.0,l ysoPC.a.C20.3, PC.aa.C26.0, lysoPC.a.C17.0, lysoPC.a.C28.1, C16, C18, lysoPC.a.C18.0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873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6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-128"/>
                        </a:rPr>
                        <a:t>C8.1, Phe, C5, C0, Pro, C3, H1, Val, xLeu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5</Words>
  <Application>Microsoft Office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-Design</vt:lpstr>
      <vt:lpstr>Slide 1</vt:lpstr>
    </vt:vector>
  </TitlesOfParts>
  <Company>Helmholtz Zentrum Münche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ann-kristin.petersen</dc:creator>
  <cp:lastModifiedBy>jolano</cp:lastModifiedBy>
  <cp:revision>214</cp:revision>
  <dcterms:created xsi:type="dcterms:W3CDTF">2011-06-19T12:35:05Z</dcterms:created>
  <dcterms:modified xsi:type="dcterms:W3CDTF">2014-03-27T17:49:03Z</dcterms:modified>
</cp:coreProperties>
</file>